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6" r:id="rId2"/>
  </p:sldIdLst>
  <p:sldSz cx="6858000" cy="9906000" type="A4"/>
  <p:notesSz cx="6797675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79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ee Faux" initials="MF" lastIdx="1" clrIdx="0">
    <p:extLst>
      <p:ext uri="{19B8F6BF-5375-455C-9EA6-DF929625EA0E}">
        <p15:presenceInfo xmlns:p15="http://schemas.microsoft.com/office/powerpoint/2012/main" userId="S::faux@wehi.edu.au::dc70cead-74d4-4051-8726-6dcf08785fc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62"/>
    <p:restoredTop sz="94643"/>
  </p:normalViewPr>
  <p:slideViewPr>
    <p:cSldViewPr snapToGrid="0" snapToObjects="1" showGuides="1">
      <p:cViewPr varScale="1">
        <p:scale>
          <a:sx n="89" d="100"/>
          <a:sy n="89" d="100"/>
        </p:scale>
        <p:origin x="3448" y="168"/>
      </p:cViewPr>
      <p:guideLst>
        <p:guide orient="horz" pos="5479"/>
        <p:guide pos="20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600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317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524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831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083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5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862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381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477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270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696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00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64955EA-F845-3442-B307-890B55FA7FD4}"/>
              </a:ext>
            </a:extLst>
          </p:cNvPr>
          <p:cNvSpPr txBox="1"/>
          <p:nvPr/>
        </p:nvSpPr>
        <p:spPr>
          <a:xfrm>
            <a:off x="95786" y="22349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AD89992-7E13-4440-A0F4-F6C3D528A42D}"/>
              </a:ext>
            </a:extLst>
          </p:cNvPr>
          <p:cNvSpPr txBox="1"/>
          <p:nvPr/>
        </p:nvSpPr>
        <p:spPr>
          <a:xfrm>
            <a:off x="141344" y="32073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FAA4E57-D57A-9543-9B74-0ADF3081202B}"/>
              </a:ext>
            </a:extLst>
          </p:cNvPr>
          <p:cNvSpPr txBox="1"/>
          <p:nvPr/>
        </p:nvSpPr>
        <p:spPr>
          <a:xfrm>
            <a:off x="3000769" y="31049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C2AF0EC-8B87-3C40-AE19-B09F30AD3F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07" t="14187" r="13901" b="57733"/>
          <a:stretch/>
        </p:blipFill>
        <p:spPr>
          <a:xfrm>
            <a:off x="284973" y="517452"/>
            <a:ext cx="5677786" cy="272193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2ACCD7A-35C3-4F31-BAFF-50BD93A3ACAB}"/>
              </a:ext>
            </a:extLst>
          </p:cNvPr>
          <p:cNvSpPr txBox="1"/>
          <p:nvPr/>
        </p:nvSpPr>
        <p:spPr>
          <a:xfrm>
            <a:off x="276532" y="3619707"/>
            <a:ext cx="5686227" cy="26250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AU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Figure S1.</a:t>
            </a:r>
            <a:r>
              <a:rPr lang="en-AU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AU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CLK1-CreERT2 BAC transgenic mice faithfully label Dclk1+ cells in the colonic epithelium. </a:t>
            </a:r>
            <a:r>
              <a:rPr lang="en-AU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A)</a:t>
            </a:r>
            <a:r>
              <a:rPr lang="en-AU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AU" sz="1200" i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clk1</a:t>
            </a:r>
            <a:r>
              <a:rPr lang="en-AU" sz="1200" i="1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re/+</a:t>
            </a:r>
            <a:r>
              <a:rPr lang="en-AU" sz="1200" i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;</a:t>
            </a:r>
            <a:r>
              <a:rPr lang="en-AU" sz="1200" i="1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osa</a:t>
            </a:r>
            <a:r>
              <a:rPr lang="en-AU" sz="1200" i="1" baseline="300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acZ</a:t>
            </a:r>
            <a:r>
              <a:rPr lang="en-AU" sz="1200" i="1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/+</a:t>
            </a:r>
            <a:r>
              <a:rPr lang="en-AU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ice were treated with tamoxifen for two consecutive days and 48 hrs later colonic epithelium was isolated and incubated in X-Gal staining solution before tissue was fixed and counterstained with Nuclear fast red. (B) Dclk1+ cells were stained using anti-Dclk1 antibody on X-Gal stained colonic tissue from </a:t>
            </a:r>
            <a:r>
              <a:rPr lang="en-AU" sz="1200" i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clk1</a:t>
            </a:r>
            <a:r>
              <a:rPr lang="en-AU" sz="1200" i="1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re/+</a:t>
            </a:r>
            <a:r>
              <a:rPr lang="en-AU" sz="1200" i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;</a:t>
            </a:r>
            <a:r>
              <a:rPr lang="en-AU" sz="1200" i="1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osa</a:t>
            </a:r>
            <a:r>
              <a:rPr lang="en-AU" sz="1200" i="1" baseline="300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acZ</a:t>
            </a:r>
            <a:r>
              <a:rPr lang="en-AU" sz="1200" i="1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/+</a:t>
            </a:r>
            <a:r>
              <a:rPr lang="en-AU" sz="1200" i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ice.</a:t>
            </a:r>
            <a:endParaRPr lang="en-AU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fontAlgn="base">
              <a:lnSpc>
                <a:spcPct val="200000"/>
              </a:lnSpc>
            </a:pPr>
            <a:r>
              <a:rPr lang="en-AU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en-AU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0128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66</TotalTime>
  <Words>87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Rice</dc:creator>
  <cp:lastModifiedBy>Maree Faux</cp:lastModifiedBy>
  <cp:revision>191</cp:revision>
  <cp:lastPrinted>2021-04-20T03:50:21Z</cp:lastPrinted>
  <dcterms:created xsi:type="dcterms:W3CDTF">2020-10-22T05:38:27Z</dcterms:created>
  <dcterms:modified xsi:type="dcterms:W3CDTF">2021-12-21T00:16:43Z</dcterms:modified>
</cp:coreProperties>
</file>